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48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2">
  <dgm:title val=""/>
  <dgm:desc val=""/>
  <dgm:catLst>
    <dgm:cat type="mainScheme" pri="10200"/>
  </dgm:catLst>
  <dgm:styleLbl name="node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lig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l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2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f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con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align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trAlignAcc1">
    <dgm:fillClrLst meth="repeat">
      <a:schemeClr val="dk2">
        <a:alpha val="4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F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Align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B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fgAcc0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2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3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4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1"/>
    </dgm:linClrLst>
    <dgm:effectClrLst/>
    <dgm:txLinClrLst/>
    <dgm:txFillClrLst meth="repeat">
      <a:schemeClr val="dk2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2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0_2">
  <dgm:title val=""/>
  <dgm:desc val=""/>
  <dgm:catLst>
    <dgm:cat type="mainScheme" pri="10200"/>
  </dgm:catLst>
  <dgm:styleLbl name="node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lig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l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2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f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con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align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trAlignAcc1">
    <dgm:fillClrLst meth="repeat">
      <a:schemeClr val="dk2">
        <a:alpha val="4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F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Align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B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fgAcc0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2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3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4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1"/>
    </dgm:linClrLst>
    <dgm:effectClrLst/>
    <dgm:txLinClrLst/>
    <dgm:txFillClrLst meth="repeat">
      <a:schemeClr val="dk2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2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2E96266-5422-4151-8EA0-F3F3FB568878}" type="doc">
      <dgm:prSet loTypeId="urn:microsoft.com/office/officeart/2005/8/layout/venn1" loCatId="relationship" qsTypeId="urn:microsoft.com/office/officeart/2005/8/quickstyle/simple1" qsCatId="simple" csTypeId="urn:microsoft.com/office/officeart/2005/8/colors/accent0_2" csCatId="mainScheme" phldr="1"/>
      <dgm:spPr/>
    </dgm:pt>
    <dgm:pt modelId="{4C938ED9-B6F4-4E3E-9044-41E2F4BD8434}">
      <dgm:prSet phldrT="[テキスト]"/>
      <dgm:spPr/>
      <dgm:t>
        <a:bodyPr/>
        <a:lstStyle/>
        <a:p>
          <a:r>
            <a:rPr kumimoji="1" lang="ja-JP" altLang="en-US" dirty="0" smtClean="0"/>
            <a:t>　</a:t>
          </a:r>
          <a:endParaRPr kumimoji="1" lang="ja-JP" altLang="en-US" dirty="0"/>
        </a:p>
      </dgm:t>
    </dgm:pt>
    <dgm:pt modelId="{9FF76BAF-7B20-4567-9652-271AAD0FF0D8}" type="parTrans" cxnId="{D1535BD3-3DC3-470E-A8C4-25808F5AB3F2}">
      <dgm:prSet/>
      <dgm:spPr/>
      <dgm:t>
        <a:bodyPr/>
        <a:lstStyle/>
        <a:p>
          <a:endParaRPr kumimoji="1" lang="ja-JP" altLang="en-US"/>
        </a:p>
      </dgm:t>
    </dgm:pt>
    <dgm:pt modelId="{2879E37E-4EFE-401B-A61A-8AD7E82A67E4}" type="sibTrans" cxnId="{D1535BD3-3DC3-470E-A8C4-25808F5AB3F2}">
      <dgm:prSet/>
      <dgm:spPr/>
      <dgm:t>
        <a:bodyPr/>
        <a:lstStyle/>
        <a:p>
          <a:endParaRPr kumimoji="1" lang="ja-JP" altLang="en-US"/>
        </a:p>
      </dgm:t>
    </dgm:pt>
    <dgm:pt modelId="{62D73BCB-F885-402F-A15C-7357D5474EB5}">
      <dgm:prSet phldrT="[テキスト]"/>
      <dgm:spPr/>
      <dgm:t>
        <a:bodyPr/>
        <a:lstStyle/>
        <a:p>
          <a:r>
            <a:rPr kumimoji="1" lang="ja-JP" altLang="en-US" dirty="0" smtClean="0"/>
            <a:t>　</a:t>
          </a:r>
          <a:endParaRPr kumimoji="1" lang="ja-JP" altLang="en-US" dirty="0"/>
        </a:p>
      </dgm:t>
    </dgm:pt>
    <dgm:pt modelId="{1B3E1797-39DD-47E7-BC25-1CCE14F8861B}" type="parTrans" cxnId="{96F0B9FA-3D52-4F6D-A413-29B4FB5DC27B}">
      <dgm:prSet/>
      <dgm:spPr/>
      <dgm:t>
        <a:bodyPr/>
        <a:lstStyle/>
        <a:p>
          <a:endParaRPr kumimoji="1" lang="ja-JP" altLang="en-US"/>
        </a:p>
      </dgm:t>
    </dgm:pt>
    <dgm:pt modelId="{0868B6F3-D3CF-4238-B191-EB1D13265FAF}" type="sibTrans" cxnId="{96F0B9FA-3D52-4F6D-A413-29B4FB5DC27B}">
      <dgm:prSet/>
      <dgm:spPr/>
      <dgm:t>
        <a:bodyPr/>
        <a:lstStyle/>
        <a:p>
          <a:endParaRPr kumimoji="1" lang="ja-JP" altLang="en-US"/>
        </a:p>
      </dgm:t>
    </dgm:pt>
    <dgm:pt modelId="{54EA82F2-04E4-49B8-96F8-DD309873C406}">
      <dgm:prSet phldrT="[テキスト]"/>
      <dgm:spPr/>
      <dgm:t>
        <a:bodyPr/>
        <a:lstStyle/>
        <a:p>
          <a:r>
            <a:rPr kumimoji="1" lang="ja-JP" altLang="en-US" dirty="0" smtClean="0"/>
            <a:t>　</a:t>
          </a:r>
          <a:endParaRPr kumimoji="1" lang="ja-JP" altLang="en-US" dirty="0"/>
        </a:p>
      </dgm:t>
    </dgm:pt>
    <dgm:pt modelId="{81B6C997-BF37-48B5-95DD-4CF36954373A}" type="sibTrans" cxnId="{8F2B13AC-DA6C-40CF-A454-D72E43A56EEE}">
      <dgm:prSet/>
      <dgm:spPr/>
      <dgm:t>
        <a:bodyPr/>
        <a:lstStyle/>
        <a:p>
          <a:endParaRPr kumimoji="1" lang="ja-JP" altLang="en-US"/>
        </a:p>
      </dgm:t>
    </dgm:pt>
    <dgm:pt modelId="{710B7225-19E7-491F-A037-4A569E9C42D5}" type="parTrans" cxnId="{8F2B13AC-DA6C-40CF-A454-D72E43A56EEE}">
      <dgm:prSet/>
      <dgm:spPr/>
      <dgm:t>
        <a:bodyPr/>
        <a:lstStyle/>
        <a:p>
          <a:endParaRPr kumimoji="1" lang="ja-JP" altLang="en-US"/>
        </a:p>
      </dgm:t>
    </dgm:pt>
    <dgm:pt modelId="{EA946C14-59CB-41F4-A86B-E7700E46939E}" type="pres">
      <dgm:prSet presAssocID="{32E96266-5422-4151-8EA0-F3F3FB568878}" presName="compositeShape" presStyleCnt="0">
        <dgm:presLayoutVars>
          <dgm:chMax val="7"/>
          <dgm:dir/>
          <dgm:resizeHandles val="exact"/>
        </dgm:presLayoutVars>
      </dgm:prSet>
      <dgm:spPr/>
    </dgm:pt>
    <dgm:pt modelId="{96B07F8C-F311-49D9-8D48-D96E80604D6B}" type="pres">
      <dgm:prSet presAssocID="{4C938ED9-B6F4-4E3E-9044-41E2F4BD8434}" presName="circ1" presStyleLbl="vennNode1" presStyleIdx="0" presStyleCnt="3" custLinFactNeighborX="-51496" custLinFactNeighborY="35666"/>
      <dgm:spPr/>
      <dgm:t>
        <a:bodyPr/>
        <a:lstStyle/>
        <a:p>
          <a:endParaRPr kumimoji="1" lang="ja-JP" altLang="en-US"/>
        </a:p>
      </dgm:t>
    </dgm:pt>
    <dgm:pt modelId="{DCD62682-4822-4288-A69E-EDF30A2A9912}" type="pres">
      <dgm:prSet presAssocID="{4C938ED9-B6F4-4E3E-9044-41E2F4BD8434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  <dgm:pt modelId="{4D2133FD-0DAD-4B1B-8EFE-589A6AC80E82}" type="pres">
      <dgm:prSet presAssocID="{54EA82F2-04E4-49B8-96F8-DD309873C406}" presName="circ2" presStyleLbl="vennNode1" presStyleIdx="1" presStyleCnt="3" custLinFactNeighborX="-76057" custLinFactNeighborY="-9111"/>
      <dgm:spPr/>
      <dgm:t>
        <a:bodyPr/>
        <a:lstStyle/>
        <a:p>
          <a:endParaRPr kumimoji="1" lang="ja-JP" altLang="en-US"/>
        </a:p>
      </dgm:t>
    </dgm:pt>
    <dgm:pt modelId="{A732A30B-EA9C-47EF-90B2-8D4FDE3B63A1}" type="pres">
      <dgm:prSet presAssocID="{54EA82F2-04E4-49B8-96F8-DD309873C40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  <dgm:pt modelId="{026B540D-D4C0-4CDF-892F-83FFD22751D7}" type="pres">
      <dgm:prSet presAssocID="{62D73BCB-F885-402F-A15C-7357D5474EB5}" presName="circ3" presStyleLbl="vennNode1" presStyleIdx="2" presStyleCnt="3" custLinFactNeighborX="-23372" custLinFactNeighborY="-9110"/>
      <dgm:spPr/>
      <dgm:t>
        <a:bodyPr/>
        <a:lstStyle/>
        <a:p>
          <a:endParaRPr kumimoji="1" lang="ja-JP" altLang="en-US"/>
        </a:p>
      </dgm:t>
    </dgm:pt>
    <dgm:pt modelId="{042A03FC-1241-49FD-9A1E-8B07F958EC72}" type="pres">
      <dgm:prSet presAssocID="{62D73BCB-F885-402F-A15C-7357D5474EB5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</dgm:ptLst>
  <dgm:cxnLst>
    <dgm:cxn modelId="{96F0B9FA-3D52-4F6D-A413-29B4FB5DC27B}" srcId="{32E96266-5422-4151-8EA0-F3F3FB568878}" destId="{62D73BCB-F885-402F-A15C-7357D5474EB5}" srcOrd="2" destOrd="0" parTransId="{1B3E1797-39DD-47E7-BC25-1CCE14F8861B}" sibTransId="{0868B6F3-D3CF-4238-B191-EB1D13265FAF}"/>
    <dgm:cxn modelId="{61F7F291-F50F-42F5-AB58-16FB1ED0DAB8}" type="presOf" srcId="{32E96266-5422-4151-8EA0-F3F3FB568878}" destId="{EA946C14-59CB-41F4-A86B-E7700E46939E}" srcOrd="0" destOrd="0" presId="urn:microsoft.com/office/officeart/2005/8/layout/venn1"/>
    <dgm:cxn modelId="{F46B8F61-E80F-4C80-BA28-69D5B198F909}" type="presOf" srcId="{62D73BCB-F885-402F-A15C-7357D5474EB5}" destId="{026B540D-D4C0-4CDF-892F-83FFD22751D7}" srcOrd="0" destOrd="0" presId="urn:microsoft.com/office/officeart/2005/8/layout/venn1"/>
    <dgm:cxn modelId="{D1535BD3-3DC3-470E-A8C4-25808F5AB3F2}" srcId="{32E96266-5422-4151-8EA0-F3F3FB568878}" destId="{4C938ED9-B6F4-4E3E-9044-41E2F4BD8434}" srcOrd="0" destOrd="0" parTransId="{9FF76BAF-7B20-4567-9652-271AAD0FF0D8}" sibTransId="{2879E37E-4EFE-401B-A61A-8AD7E82A67E4}"/>
    <dgm:cxn modelId="{8F2B13AC-DA6C-40CF-A454-D72E43A56EEE}" srcId="{32E96266-5422-4151-8EA0-F3F3FB568878}" destId="{54EA82F2-04E4-49B8-96F8-DD309873C406}" srcOrd="1" destOrd="0" parTransId="{710B7225-19E7-491F-A037-4A569E9C42D5}" sibTransId="{81B6C997-BF37-48B5-95DD-4CF36954373A}"/>
    <dgm:cxn modelId="{506FE591-D0C7-4662-B446-7CF62420FDA3}" type="presOf" srcId="{54EA82F2-04E4-49B8-96F8-DD309873C406}" destId="{A732A30B-EA9C-47EF-90B2-8D4FDE3B63A1}" srcOrd="1" destOrd="0" presId="urn:microsoft.com/office/officeart/2005/8/layout/venn1"/>
    <dgm:cxn modelId="{B996B467-9688-4DD0-B613-D66C220328E8}" type="presOf" srcId="{62D73BCB-F885-402F-A15C-7357D5474EB5}" destId="{042A03FC-1241-49FD-9A1E-8B07F958EC72}" srcOrd="1" destOrd="0" presId="urn:microsoft.com/office/officeart/2005/8/layout/venn1"/>
    <dgm:cxn modelId="{C8BED04B-FA4A-4B51-B186-EBBBDF4D744C}" type="presOf" srcId="{4C938ED9-B6F4-4E3E-9044-41E2F4BD8434}" destId="{96B07F8C-F311-49D9-8D48-D96E80604D6B}" srcOrd="0" destOrd="0" presId="urn:microsoft.com/office/officeart/2005/8/layout/venn1"/>
    <dgm:cxn modelId="{7616561E-7ADC-4A45-8D7F-447A8627231F}" type="presOf" srcId="{4C938ED9-B6F4-4E3E-9044-41E2F4BD8434}" destId="{DCD62682-4822-4288-A69E-EDF30A2A9912}" srcOrd="1" destOrd="0" presId="urn:microsoft.com/office/officeart/2005/8/layout/venn1"/>
    <dgm:cxn modelId="{E99D11C0-0736-47CA-A1D7-8E02389A78AD}" type="presOf" srcId="{54EA82F2-04E4-49B8-96F8-DD309873C406}" destId="{4D2133FD-0DAD-4B1B-8EFE-589A6AC80E82}" srcOrd="0" destOrd="0" presId="urn:microsoft.com/office/officeart/2005/8/layout/venn1"/>
    <dgm:cxn modelId="{B13B7A95-4939-400C-A614-AE9FCA38FC90}" type="presParOf" srcId="{EA946C14-59CB-41F4-A86B-E7700E46939E}" destId="{96B07F8C-F311-49D9-8D48-D96E80604D6B}" srcOrd="0" destOrd="0" presId="urn:microsoft.com/office/officeart/2005/8/layout/venn1"/>
    <dgm:cxn modelId="{64A60AFC-C4DA-479C-BD58-3CA991CFF808}" type="presParOf" srcId="{EA946C14-59CB-41F4-A86B-E7700E46939E}" destId="{DCD62682-4822-4288-A69E-EDF30A2A9912}" srcOrd="1" destOrd="0" presId="urn:microsoft.com/office/officeart/2005/8/layout/venn1"/>
    <dgm:cxn modelId="{26A0BB12-EF0F-489B-AF5E-1E82C729DEE5}" type="presParOf" srcId="{EA946C14-59CB-41F4-A86B-E7700E46939E}" destId="{4D2133FD-0DAD-4B1B-8EFE-589A6AC80E82}" srcOrd="2" destOrd="0" presId="urn:microsoft.com/office/officeart/2005/8/layout/venn1"/>
    <dgm:cxn modelId="{EE841835-6344-4416-BB55-2DC80FBCE4AB}" type="presParOf" srcId="{EA946C14-59CB-41F4-A86B-E7700E46939E}" destId="{A732A30B-EA9C-47EF-90B2-8D4FDE3B63A1}" srcOrd="3" destOrd="0" presId="urn:microsoft.com/office/officeart/2005/8/layout/venn1"/>
    <dgm:cxn modelId="{8B6A0882-A41A-45BB-A95A-AD3C8099D15D}" type="presParOf" srcId="{EA946C14-59CB-41F4-A86B-E7700E46939E}" destId="{026B540D-D4C0-4CDF-892F-83FFD22751D7}" srcOrd="4" destOrd="0" presId="urn:microsoft.com/office/officeart/2005/8/layout/venn1"/>
    <dgm:cxn modelId="{69ABCDCF-DAEB-41A0-9420-24E2856DB35A}" type="presParOf" srcId="{EA946C14-59CB-41F4-A86B-E7700E46939E}" destId="{042A03FC-1241-49FD-9A1E-8B07F958EC72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32E96266-5422-4151-8EA0-F3F3FB568878}" type="doc">
      <dgm:prSet loTypeId="urn:microsoft.com/office/officeart/2005/8/layout/venn1" loCatId="relationship" qsTypeId="urn:microsoft.com/office/officeart/2005/8/quickstyle/simple1" qsCatId="simple" csTypeId="urn:microsoft.com/office/officeart/2005/8/colors/accent0_2" csCatId="mainScheme" phldr="1"/>
      <dgm:spPr/>
    </dgm:pt>
    <dgm:pt modelId="{4C938ED9-B6F4-4E3E-9044-41E2F4BD8434}">
      <dgm:prSet phldrT="[テキスト]"/>
      <dgm:spPr/>
      <dgm:t>
        <a:bodyPr/>
        <a:lstStyle/>
        <a:p>
          <a:r>
            <a:rPr kumimoji="1" lang="ja-JP" altLang="en-US" dirty="0" smtClean="0"/>
            <a:t>　</a:t>
          </a:r>
          <a:endParaRPr kumimoji="1" lang="ja-JP" altLang="en-US" dirty="0"/>
        </a:p>
      </dgm:t>
    </dgm:pt>
    <dgm:pt modelId="{9FF76BAF-7B20-4567-9652-271AAD0FF0D8}" type="parTrans" cxnId="{D1535BD3-3DC3-470E-A8C4-25808F5AB3F2}">
      <dgm:prSet/>
      <dgm:spPr/>
      <dgm:t>
        <a:bodyPr/>
        <a:lstStyle/>
        <a:p>
          <a:endParaRPr kumimoji="1" lang="ja-JP" altLang="en-US"/>
        </a:p>
      </dgm:t>
    </dgm:pt>
    <dgm:pt modelId="{2879E37E-4EFE-401B-A61A-8AD7E82A67E4}" type="sibTrans" cxnId="{D1535BD3-3DC3-470E-A8C4-25808F5AB3F2}">
      <dgm:prSet/>
      <dgm:spPr/>
      <dgm:t>
        <a:bodyPr/>
        <a:lstStyle/>
        <a:p>
          <a:endParaRPr kumimoji="1" lang="ja-JP" altLang="en-US"/>
        </a:p>
      </dgm:t>
    </dgm:pt>
    <dgm:pt modelId="{62D73BCB-F885-402F-A15C-7357D5474EB5}">
      <dgm:prSet phldrT="[テキスト]"/>
      <dgm:spPr/>
      <dgm:t>
        <a:bodyPr/>
        <a:lstStyle/>
        <a:p>
          <a:r>
            <a:rPr kumimoji="1" lang="ja-JP" altLang="en-US" dirty="0" smtClean="0"/>
            <a:t>　</a:t>
          </a:r>
          <a:endParaRPr kumimoji="1" lang="ja-JP" altLang="en-US" dirty="0"/>
        </a:p>
      </dgm:t>
    </dgm:pt>
    <dgm:pt modelId="{1B3E1797-39DD-47E7-BC25-1CCE14F8861B}" type="parTrans" cxnId="{96F0B9FA-3D52-4F6D-A413-29B4FB5DC27B}">
      <dgm:prSet/>
      <dgm:spPr/>
      <dgm:t>
        <a:bodyPr/>
        <a:lstStyle/>
        <a:p>
          <a:endParaRPr kumimoji="1" lang="ja-JP" altLang="en-US"/>
        </a:p>
      </dgm:t>
    </dgm:pt>
    <dgm:pt modelId="{0868B6F3-D3CF-4238-B191-EB1D13265FAF}" type="sibTrans" cxnId="{96F0B9FA-3D52-4F6D-A413-29B4FB5DC27B}">
      <dgm:prSet/>
      <dgm:spPr/>
      <dgm:t>
        <a:bodyPr/>
        <a:lstStyle/>
        <a:p>
          <a:endParaRPr kumimoji="1" lang="ja-JP" altLang="en-US"/>
        </a:p>
      </dgm:t>
    </dgm:pt>
    <dgm:pt modelId="{54EA82F2-04E4-49B8-96F8-DD309873C406}">
      <dgm:prSet phldrT="[テキスト]"/>
      <dgm:spPr/>
      <dgm:t>
        <a:bodyPr/>
        <a:lstStyle/>
        <a:p>
          <a:r>
            <a:rPr kumimoji="1" lang="ja-JP" altLang="en-US" dirty="0" smtClean="0"/>
            <a:t>　</a:t>
          </a:r>
          <a:endParaRPr kumimoji="1" lang="ja-JP" altLang="en-US" dirty="0"/>
        </a:p>
      </dgm:t>
    </dgm:pt>
    <dgm:pt modelId="{81B6C997-BF37-48B5-95DD-4CF36954373A}" type="sibTrans" cxnId="{8F2B13AC-DA6C-40CF-A454-D72E43A56EEE}">
      <dgm:prSet/>
      <dgm:spPr/>
      <dgm:t>
        <a:bodyPr/>
        <a:lstStyle/>
        <a:p>
          <a:endParaRPr kumimoji="1" lang="ja-JP" altLang="en-US"/>
        </a:p>
      </dgm:t>
    </dgm:pt>
    <dgm:pt modelId="{710B7225-19E7-491F-A037-4A569E9C42D5}" type="parTrans" cxnId="{8F2B13AC-DA6C-40CF-A454-D72E43A56EEE}">
      <dgm:prSet/>
      <dgm:spPr/>
      <dgm:t>
        <a:bodyPr/>
        <a:lstStyle/>
        <a:p>
          <a:endParaRPr kumimoji="1" lang="ja-JP" altLang="en-US"/>
        </a:p>
      </dgm:t>
    </dgm:pt>
    <dgm:pt modelId="{EA946C14-59CB-41F4-A86B-E7700E46939E}" type="pres">
      <dgm:prSet presAssocID="{32E96266-5422-4151-8EA0-F3F3FB568878}" presName="compositeShape" presStyleCnt="0">
        <dgm:presLayoutVars>
          <dgm:chMax val="7"/>
          <dgm:dir/>
          <dgm:resizeHandles val="exact"/>
        </dgm:presLayoutVars>
      </dgm:prSet>
      <dgm:spPr/>
    </dgm:pt>
    <dgm:pt modelId="{96B07F8C-F311-49D9-8D48-D96E80604D6B}" type="pres">
      <dgm:prSet presAssocID="{4C938ED9-B6F4-4E3E-9044-41E2F4BD8434}" presName="circ1" presStyleLbl="vennNode1" presStyleIdx="0" presStyleCnt="3" custLinFactNeighborX="-51496" custLinFactNeighborY="35666"/>
      <dgm:spPr/>
      <dgm:t>
        <a:bodyPr/>
        <a:lstStyle/>
        <a:p>
          <a:endParaRPr kumimoji="1" lang="ja-JP" altLang="en-US"/>
        </a:p>
      </dgm:t>
    </dgm:pt>
    <dgm:pt modelId="{DCD62682-4822-4288-A69E-EDF30A2A9912}" type="pres">
      <dgm:prSet presAssocID="{4C938ED9-B6F4-4E3E-9044-41E2F4BD8434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  <dgm:pt modelId="{4D2133FD-0DAD-4B1B-8EFE-589A6AC80E82}" type="pres">
      <dgm:prSet presAssocID="{54EA82F2-04E4-49B8-96F8-DD309873C406}" presName="circ2" presStyleLbl="vennNode1" presStyleIdx="1" presStyleCnt="3" custLinFactNeighborX="-76057" custLinFactNeighborY="-9111"/>
      <dgm:spPr/>
      <dgm:t>
        <a:bodyPr/>
        <a:lstStyle/>
        <a:p>
          <a:endParaRPr kumimoji="1" lang="ja-JP" altLang="en-US"/>
        </a:p>
      </dgm:t>
    </dgm:pt>
    <dgm:pt modelId="{A732A30B-EA9C-47EF-90B2-8D4FDE3B63A1}" type="pres">
      <dgm:prSet presAssocID="{54EA82F2-04E4-49B8-96F8-DD309873C40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  <dgm:pt modelId="{026B540D-D4C0-4CDF-892F-83FFD22751D7}" type="pres">
      <dgm:prSet presAssocID="{62D73BCB-F885-402F-A15C-7357D5474EB5}" presName="circ3" presStyleLbl="vennNode1" presStyleIdx="2" presStyleCnt="3" custLinFactNeighborX="-23372" custLinFactNeighborY="-9110"/>
      <dgm:spPr/>
      <dgm:t>
        <a:bodyPr/>
        <a:lstStyle/>
        <a:p>
          <a:endParaRPr kumimoji="1" lang="ja-JP" altLang="en-US"/>
        </a:p>
      </dgm:t>
    </dgm:pt>
    <dgm:pt modelId="{042A03FC-1241-49FD-9A1E-8B07F958EC72}" type="pres">
      <dgm:prSet presAssocID="{62D73BCB-F885-402F-A15C-7357D5474EB5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kumimoji="1" lang="ja-JP" altLang="en-US"/>
        </a:p>
      </dgm:t>
    </dgm:pt>
  </dgm:ptLst>
  <dgm:cxnLst>
    <dgm:cxn modelId="{9C788B64-C75B-4A44-B26C-163FE70FBCFC}" type="presOf" srcId="{62D73BCB-F885-402F-A15C-7357D5474EB5}" destId="{026B540D-D4C0-4CDF-892F-83FFD22751D7}" srcOrd="0" destOrd="0" presId="urn:microsoft.com/office/officeart/2005/8/layout/venn1"/>
    <dgm:cxn modelId="{7AED38E8-98B8-4449-96F3-C4AE8F7B6F5C}" type="presOf" srcId="{54EA82F2-04E4-49B8-96F8-DD309873C406}" destId="{A732A30B-EA9C-47EF-90B2-8D4FDE3B63A1}" srcOrd="1" destOrd="0" presId="urn:microsoft.com/office/officeart/2005/8/layout/venn1"/>
    <dgm:cxn modelId="{60015D8E-D70D-46E4-BB57-E4AA410FB068}" type="presOf" srcId="{54EA82F2-04E4-49B8-96F8-DD309873C406}" destId="{4D2133FD-0DAD-4B1B-8EFE-589A6AC80E82}" srcOrd="0" destOrd="0" presId="urn:microsoft.com/office/officeart/2005/8/layout/venn1"/>
    <dgm:cxn modelId="{A2E84EC0-2DBF-46B5-A57F-70D090F4EEDA}" type="presOf" srcId="{4C938ED9-B6F4-4E3E-9044-41E2F4BD8434}" destId="{DCD62682-4822-4288-A69E-EDF30A2A9912}" srcOrd="1" destOrd="0" presId="urn:microsoft.com/office/officeart/2005/8/layout/venn1"/>
    <dgm:cxn modelId="{595DD3AD-5172-4343-8865-E7FFF18AE3E9}" type="presOf" srcId="{32E96266-5422-4151-8EA0-F3F3FB568878}" destId="{EA946C14-59CB-41F4-A86B-E7700E46939E}" srcOrd="0" destOrd="0" presId="urn:microsoft.com/office/officeart/2005/8/layout/venn1"/>
    <dgm:cxn modelId="{834B3304-13CE-49C8-9ED3-B086BFBA12D6}" type="presOf" srcId="{62D73BCB-F885-402F-A15C-7357D5474EB5}" destId="{042A03FC-1241-49FD-9A1E-8B07F958EC72}" srcOrd="1" destOrd="0" presId="urn:microsoft.com/office/officeart/2005/8/layout/venn1"/>
    <dgm:cxn modelId="{9B0C8998-90C0-430B-BC1F-E7607E4D7F19}" type="presOf" srcId="{4C938ED9-B6F4-4E3E-9044-41E2F4BD8434}" destId="{96B07F8C-F311-49D9-8D48-D96E80604D6B}" srcOrd="0" destOrd="0" presId="urn:microsoft.com/office/officeart/2005/8/layout/venn1"/>
    <dgm:cxn modelId="{D1535BD3-3DC3-470E-A8C4-25808F5AB3F2}" srcId="{32E96266-5422-4151-8EA0-F3F3FB568878}" destId="{4C938ED9-B6F4-4E3E-9044-41E2F4BD8434}" srcOrd="0" destOrd="0" parTransId="{9FF76BAF-7B20-4567-9652-271AAD0FF0D8}" sibTransId="{2879E37E-4EFE-401B-A61A-8AD7E82A67E4}"/>
    <dgm:cxn modelId="{8F2B13AC-DA6C-40CF-A454-D72E43A56EEE}" srcId="{32E96266-5422-4151-8EA0-F3F3FB568878}" destId="{54EA82F2-04E4-49B8-96F8-DD309873C406}" srcOrd="1" destOrd="0" parTransId="{710B7225-19E7-491F-A037-4A569E9C42D5}" sibTransId="{81B6C997-BF37-48B5-95DD-4CF36954373A}"/>
    <dgm:cxn modelId="{96F0B9FA-3D52-4F6D-A413-29B4FB5DC27B}" srcId="{32E96266-5422-4151-8EA0-F3F3FB568878}" destId="{62D73BCB-F885-402F-A15C-7357D5474EB5}" srcOrd="2" destOrd="0" parTransId="{1B3E1797-39DD-47E7-BC25-1CCE14F8861B}" sibTransId="{0868B6F3-D3CF-4238-B191-EB1D13265FAF}"/>
    <dgm:cxn modelId="{729BF1E3-617D-4CEA-887D-B5F86A533A19}" type="presParOf" srcId="{EA946C14-59CB-41F4-A86B-E7700E46939E}" destId="{96B07F8C-F311-49D9-8D48-D96E80604D6B}" srcOrd="0" destOrd="0" presId="urn:microsoft.com/office/officeart/2005/8/layout/venn1"/>
    <dgm:cxn modelId="{000DC90C-B646-462F-B516-B8FEB6E221A5}" type="presParOf" srcId="{EA946C14-59CB-41F4-A86B-E7700E46939E}" destId="{DCD62682-4822-4288-A69E-EDF30A2A9912}" srcOrd="1" destOrd="0" presId="urn:microsoft.com/office/officeart/2005/8/layout/venn1"/>
    <dgm:cxn modelId="{21307E36-D0F2-406D-AA02-C282988F6730}" type="presParOf" srcId="{EA946C14-59CB-41F4-A86B-E7700E46939E}" destId="{4D2133FD-0DAD-4B1B-8EFE-589A6AC80E82}" srcOrd="2" destOrd="0" presId="urn:microsoft.com/office/officeart/2005/8/layout/venn1"/>
    <dgm:cxn modelId="{B19F2D9C-F0F3-4A19-B2B1-A382024AD931}" type="presParOf" srcId="{EA946C14-59CB-41F4-A86B-E7700E46939E}" destId="{A732A30B-EA9C-47EF-90B2-8D4FDE3B63A1}" srcOrd="3" destOrd="0" presId="urn:microsoft.com/office/officeart/2005/8/layout/venn1"/>
    <dgm:cxn modelId="{31F6C536-CADF-4C06-A91B-F2C678D0D8C2}" type="presParOf" srcId="{EA946C14-59CB-41F4-A86B-E7700E46939E}" destId="{026B540D-D4C0-4CDF-892F-83FFD22751D7}" srcOrd="4" destOrd="0" presId="urn:microsoft.com/office/officeart/2005/8/layout/venn1"/>
    <dgm:cxn modelId="{AA56733B-CB54-4709-9E20-0289064F6C5C}" type="presParOf" srcId="{EA946C14-59CB-41F4-A86B-E7700E46939E}" destId="{042A03FC-1241-49FD-9A1E-8B07F958EC72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6B07F8C-F311-49D9-8D48-D96E80604D6B}">
      <dsp:nvSpPr>
        <dsp:cNvPr id="0" name=""/>
        <dsp:cNvSpPr/>
      </dsp:nvSpPr>
      <dsp:spPr>
        <a:xfrm>
          <a:off x="764161" y="1227306"/>
          <a:ext cx="3251200" cy="3251200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ja-JP" altLang="en-US" sz="6500" kern="1200" dirty="0" smtClean="0"/>
            <a:t>　</a:t>
          </a:r>
          <a:endParaRPr kumimoji="1" lang="ja-JP" altLang="en-US" sz="6500" kern="1200" dirty="0"/>
        </a:p>
      </dsp:txBody>
      <dsp:txXfrm>
        <a:off x="1197655" y="1796266"/>
        <a:ext cx="2384213" cy="1463040"/>
      </dsp:txXfrm>
    </dsp:sp>
    <dsp:sp modelId="{4D2133FD-0DAD-4B1B-8EFE-589A6AC80E82}">
      <dsp:nvSpPr>
        <dsp:cNvPr id="0" name=""/>
        <dsp:cNvSpPr/>
      </dsp:nvSpPr>
      <dsp:spPr>
        <a:xfrm>
          <a:off x="1138775" y="1803516"/>
          <a:ext cx="3251200" cy="3251200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ja-JP" altLang="en-US" sz="6500" kern="1200" dirty="0" smtClean="0"/>
            <a:t>　</a:t>
          </a:r>
          <a:endParaRPr kumimoji="1" lang="ja-JP" altLang="en-US" sz="6500" kern="1200" dirty="0"/>
        </a:p>
      </dsp:txBody>
      <dsp:txXfrm>
        <a:off x="2133101" y="2643409"/>
        <a:ext cx="1950720" cy="1788160"/>
      </dsp:txXfrm>
    </dsp:sp>
    <dsp:sp modelId="{026B540D-D4C0-4CDF-892F-83FFD22751D7}">
      <dsp:nvSpPr>
        <dsp:cNvPr id="0" name=""/>
        <dsp:cNvSpPr/>
      </dsp:nvSpPr>
      <dsp:spPr>
        <a:xfrm>
          <a:off x="505387" y="1803549"/>
          <a:ext cx="3251200" cy="3251200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ja-JP" altLang="en-US" sz="6500" kern="1200" dirty="0" smtClean="0"/>
            <a:t>　</a:t>
          </a:r>
          <a:endParaRPr kumimoji="1" lang="ja-JP" altLang="en-US" sz="6500" kern="1200" dirty="0"/>
        </a:p>
      </dsp:txBody>
      <dsp:txXfrm>
        <a:off x="811542" y="2643442"/>
        <a:ext cx="1950720" cy="1788160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6B07F8C-F311-49D9-8D48-D96E80604D6B}">
      <dsp:nvSpPr>
        <dsp:cNvPr id="0" name=""/>
        <dsp:cNvSpPr/>
      </dsp:nvSpPr>
      <dsp:spPr>
        <a:xfrm>
          <a:off x="764161" y="1227306"/>
          <a:ext cx="3251200" cy="3251200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ja-JP" altLang="en-US" sz="6500" kern="1200" dirty="0" smtClean="0"/>
            <a:t>　</a:t>
          </a:r>
          <a:endParaRPr kumimoji="1" lang="ja-JP" altLang="en-US" sz="6500" kern="1200" dirty="0"/>
        </a:p>
      </dsp:txBody>
      <dsp:txXfrm>
        <a:off x="1197655" y="1796266"/>
        <a:ext cx="2384213" cy="1463040"/>
      </dsp:txXfrm>
    </dsp:sp>
    <dsp:sp modelId="{4D2133FD-0DAD-4B1B-8EFE-589A6AC80E82}">
      <dsp:nvSpPr>
        <dsp:cNvPr id="0" name=""/>
        <dsp:cNvSpPr/>
      </dsp:nvSpPr>
      <dsp:spPr>
        <a:xfrm>
          <a:off x="1138775" y="1803516"/>
          <a:ext cx="3251200" cy="3251200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ja-JP" altLang="en-US" sz="6500" kern="1200" dirty="0" smtClean="0"/>
            <a:t>　</a:t>
          </a:r>
          <a:endParaRPr kumimoji="1" lang="ja-JP" altLang="en-US" sz="6500" kern="1200" dirty="0"/>
        </a:p>
      </dsp:txBody>
      <dsp:txXfrm>
        <a:off x="2133101" y="2643409"/>
        <a:ext cx="1950720" cy="1788160"/>
      </dsp:txXfrm>
    </dsp:sp>
    <dsp:sp modelId="{026B540D-D4C0-4CDF-892F-83FFD22751D7}">
      <dsp:nvSpPr>
        <dsp:cNvPr id="0" name=""/>
        <dsp:cNvSpPr/>
      </dsp:nvSpPr>
      <dsp:spPr>
        <a:xfrm>
          <a:off x="505387" y="1803549"/>
          <a:ext cx="3251200" cy="3251200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2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kumimoji="1" lang="ja-JP" altLang="en-US" sz="6500" kern="1200" dirty="0" smtClean="0"/>
            <a:t>　</a:t>
          </a:r>
          <a:endParaRPr kumimoji="1" lang="ja-JP" altLang="en-US" sz="6500" kern="1200" dirty="0"/>
        </a:p>
      </dsp:txBody>
      <dsp:txXfrm>
        <a:off x="811542" y="2643442"/>
        <a:ext cx="1950720" cy="178816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198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311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994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6211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3687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5099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5804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8878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5580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531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452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005E0E-237D-4AEE-B633-400CAF3D888A}" type="datetimeFigureOut">
              <a:rPr kumimoji="1" lang="ja-JP" altLang="en-US" smtClean="0"/>
              <a:t>2013/6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1501D-8246-46F1-B7F4-31453E2CF7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000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3" Type="http://schemas.openxmlformats.org/officeDocument/2006/relationships/diagramLayout" Target="../diagrams/layout1.xml"/><Relationship Id="rId7" Type="http://schemas.openxmlformats.org/officeDocument/2006/relationships/diagramData" Target="../diagrams/data2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0" Type="http://schemas.openxmlformats.org/officeDocument/2006/relationships/diagramColors" Target="../diagrams/colors2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図表 3"/>
          <p:cNvGraphicFramePr/>
          <p:nvPr>
            <p:extLst>
              <p:ext uri="{D42A27DB-BD31-4B8C-83A1-F6EECF244321}">
                <p14:modId xmlns:p14="http://schemas.microsoft.com/office/powerpoint/2010/main" val="2994168126"/>
              </p:ext>
            </p:extLst>
          </p:nvPr>
        </p:nvGraphicFramePr>
        <p:xfrm>
          <a:off x="1482877" y="300075"/>
          <a:ext cx="8128000" cy="541866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3605517" y="3220091"/>
            <a:ext cx="652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1333</a:t>
            </a:r>
          </a:p>
          <a:p>
            <a:pPr algn="ctr"/>
            <a:r>
              <a:rPr lang="en-US" altLang="ja-JP" dirty="0" smtClean="0"/>
              <a:t>(87)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623148" y="1543691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9</a:t>
            </a:r>
          </a:p>
          <a:p>
            <a:pPr algn="ctr"/>
            <a:r>
              <a:rPr lang="en-US" altLang="ja-JP" dirty="0" smtClean="0"/>
              <a:t>(0.8)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153589" y="3866422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15</a:t>
            </a:r>
          </a:p>
          <a:p>
            <a:pPr algn="ctr"/>
            <a:r>
              <a:rPr lang="en-US" altLang="ja-JP" dirty="0" smtClean="0"/>
              <a:t>(1.0)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124906" y="3980185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13</a:t>
            </a:r>
          </a:p>
          <a:p>
            <a:pPr algn="ctr"/>
            <a:r>
              <a:rPr lang="en-US" altLang="ja-JP" dirty="0" smtClean="0"/>
              <a:t>(0.8)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958259" y="2459283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68</a:t>
            </a:r>
          </a:p>
          <a:p>
            <a:pPr algn="ctr"/>
            <a:r>
              <a:rPr lang="en-US" altLang="ja-JP" dirty="0" smtClean="0"/>
              <a:t>(4.4)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187154" y="2603138"/>
            <a:ext cx="6174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35</a:t>
            </a:r>
          </a:p>
          <a:p>
            <a:pPr algn="ctr"/>
            <a:r>
              <a:rPr lang="en-US" altLang="ja-JP" dirty="0" smtClean="0"/>
              <a:t>(2.3)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623147" y="4678270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/>
              <a:t>57</a:t>
            </a:r>
            <a:endParaRPr kumimoji="1" lang="en-US" altLang="ja-JP" b="1" dirty="0" smtClean="0"/>
          </a:p>
          <a:p>
            <a:pPr algn="ctr"/>
            <a:r>
              <a:rPr lang="en-US" altLang="ja-JP" dirty="0" smtClean="0"/>
              <a:t>(3.7)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707535" y="5625379"/>
            <a:ext cx="3376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dditional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File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2</a:t>
            </a:r>
            <a:r>
              <a:rPr lang="ja-JP" altLang="en-US" dirty="0"/>
              <a:t> </a:t>
            </a:r>
            <a:r>
              <a:rPr lang="en-US" altLang="ja-JP" dirty="0" err="1" smtClean="0"/>
              <a:t>Tatsukami</a:t>
            </a:r>
            <a:r>
              <a:rPr lang="en-US" altLang="ja-JP" dirty="0" smtClean="0"/>
              <a:t> Y </a:t>
            </a:r>
            <a:r>
              <a:rPr lang="en-US" altLang="ja-JP" i="1" dirty="0" smtClean="0"/>
              <a:t>et al.</a:t>
            </a:r>
            <a:endParaRPr kumimoji="1" lang="ja-JP" altLang="en-US" i="1" dirty="0"/>
          </a:p>
        </p:txBody>
      </p:sp>
      <p:graphicFrame>
        <p:nvGraphicFramePr>
          <p:cNvPr id="14" name="図表 13"/>
          <p:cNvGraphicFramePr/>
          <p:nvPr>
            <p:extLst>
              <p:ext uri="{D42A27DB-BD31-4B8C-83A1-F6EECF244321}">
                <p14:modId xmlns:p14="http://schemas.microsoft.com/office/powerpoint/2010/main" val="1040090127"/>
              </p:ext>
            </p:extLst>
          </p:nvPr>
        </p:nvGraphicFramePr>
        <p:xfrm>
          <a:off x="6310316" y="310806"/>
          <a:ext cx="8128000" cy="541866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sp>
        <p:nvSpPr>
          <p:cNvPr id="15" name="テキスト ボックス 14"/>
          <p:cNvSpPr txBox="1"/>
          <p:nvPr/>
        </p:nvSpPr>
        <p:spPr>
          <a:xfrm>
            <a:off x="8479443" y="3230822"/>
            <a:ext cx="559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712</a:t>
            </a:r>
          </a:p>
          <a:p>
            <a:pPr algn="ctr"/>
            <a:r>
              <a:rPr lang="en-US" altLang="ja-JP" dirty="0" smtClean="0"/>
              <a:t>(84)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8450587" y="1554422"/>
            <a:ext cx="6174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9</a:t>
            </a:r>
          </a:p>
          <a:p>
            <a:pPr algn="ctr"/>
            <a:r>
              <a:rPr lang="en-US" altLang="ja-JP" dirty="0" smtClean="0"/>
              <a:t>(1.1)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9981028" y="3877153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15</a:t>
            </a:r>
          </a:p>
          <a:p>
            <a:pPr algn="ctr"/>
            <a:r>
              <a:rPr lang="en-US" altLang="ja-JP" dirty="0" smtClean="0"/>
              <a:t>(1.7)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6952345" y="3990916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5</a:t>
            </a:r>
          </a:p>
          <a:p>
            <a:pPr algn="ctr"/>
            <a:r>
              <a:rPr lang="en-US" altLang="ja-JP" dirty="0" smtClean="0"/>
              <a:t>(0.6)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9785698" y="2470014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 smtClean="0"/>
              <a:t>34</a:t>
            </a:r>
          </a:p>
          <a:p>
            <a:pPr algn="ctr"/>
            <a:r>
              <a:rPr lang="en-US" altLang="ja-JP" dirty="0" smtClean="0"/>
              <a:t>(4.0)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7014592" y="2613869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/>
              <a:t>26</a:t>
            </a:r>
            <a:endParaRPr kumimoji="1" lang="en-US" altLang="ja-JP" b="1" dirty="0" smtClean="0"/>
          </a:p>
          <a:p>
            <a:pPr algn="ctr"/>
            <a:r>
              <a:rPr lang="en-US" altLang="ja-JP" dirty="0" smtClean="0"/>
              <a:t>(3.1)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450585" y="4689001"/>
            <a:ext cx="61747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/>
              <a:t>46</a:t>
            </a:r>
            <a:endParaRPr kumimoji="1" lang="en-US" altLang="ja-JP" b="1" dirty="0" smtClean="0"/>
          </a:p>
          <a:p>
            <a:pPr algn="ctr"/>
            <a:r>
              <a:rPr lang="en-US" altLang="ja-JP" dirty="0" smtClean="0"/>
              <a:t>(5.4)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742384" y="714351"/>
            <a:ext cx="23159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Free-living condition</a:t>
            </a:r>
            <a:endParaRPr kumimoji="1" lang="ja-JP" altLang="en-US" sz="2000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7646363" y="769517"/>
            <a:ext cx="22472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Symbiotic </a:t>
            </a:r>
            <a:r>
              <a:rPr kumimoji="1" lang="en-US" altLang="ja-JP" sz="2000" dirty="0" smtClean="0"/>
              <a:t>condition</a:t>
            </a:r>
            <a:endParaRPr kumimoji="1" lang="ja-JP" altLang="en-US" sz="20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756317" y="1114461"/>
            <a:ext cx="465064" cy="36933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 smtClean="0"/>
              <a:t>1</a:t>
            </a:r>
            <a:r>
              <a:rPr lang="en-US" altLang="ja-JP" baseline="30000" dirty="0" smtClean="0"/>
              <a:t>st</a:t>
            </a:r>
            <a:r>
              <a:rPr lang="en-US" altLang="ja-JP" dirty="0" smtClean="0"/>
              <a:t> </a:t>
            </a:r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867463" y="4827500"/>
            <a:ext cx="514885" cy="36933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 smtClean="0"/>
              <a:t>2</a:t>
            </a:r>
            <a:r>
              <a:rPr lang="en-US" altLang="ja-JP" baseline="30000" dirty="0" smtClean="0"/>
              <a:t>nd</a:t>
            </a:r>
            <a:r>
              <a:rPr lang="en-US" altLang="ja-JP" dirty="0" smtClean="0"/>
              <a:t> 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617328" y="4803319"/>
            <a:ext cx="485518" cy="36933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 smtClean="0"/>
              <a:t>3</a:t>
            </a:r>
            <a:r>
              <a:rPr lang="en-US" altLang="ja-JP" baseline="30000" dirty="0" smtClean="0"/>
              <a:t>rd</a:t>
            </a:r>
            <a:r>
              <a:rPr lang="en-US" altLang="ja-JP" dirty="0" smtClean="0"/>
              <a:t> 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8572392" y="1114461"/>
            <a:ext cx="465064" cy="36933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 smtClean="0"/>
              <a:t>1</a:t>
            </a:r>
            <a:r>
              <a:rPr lang="en-US" altLang="ja-JP" baseline="30000" dirty="0" smtClean="0"/>
              <a:t>st</a:t>
            </a:r>
            <a:r>
              <a:rPr lang="en-US" altLang="ja-JP" dirty="0" smtClean="0"/>
              <a:t> 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713034" y="4812752"/>
            <a:ext cx="514885" cy="36933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 smtClean="0"/>
              <a:t>2</a:t>
            </a:r>
            <a:r>
              <a:rPr lang="en-US" altLang="ja-JP" baseline="30000" dirty="0" smtClean="0"/>
              <a:t>nd</a:t>
            </a:r>
            <a:r>
              <a:rPr lang="en-US" altLang="ja-JP" dirty="0" smtClean="0"/>
              <a:t> </a:t>
            </a:r>
            <a:endParaRPr kumimoji="1" lang="ja-JP" altLang="en-US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0433403" y="4818067"/>
            <a:ext cx="485518" cy="369332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dirty="0" smtClean="0"/>
              <a:t>3</a:t>
            </a:r>
            <a:r>
              <a:rPr lang="en-US" altLang="ja-JP" baseline="30000" dirty="0" smtClean="0"/>
              <a:t>rd</a:t>
            </a:r>
            <a:r>
              <a:rPr lang="en-US" altLang="ja-JP" dirty="0" smtClean="0"/>
              <a:t>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26887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74</Words>
  <Application>Microsoft Office PowerPoint</Application>
  <PresentationFormat>ワイド画面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enko-1301</dc:creator>
  <cp:lastModifiedBy>tenko-1301</cp:lastModifiedBy>
  <cp:revision>6</cp:revision>
  <cp:lastPrinted>2013-05-24T06:50:35Z</cp:lastPrinted>
  <dcterms:created xsi:type="dcterms:W3CDTF">2013-05-24T06:30:24Z</dcterms:created>
  <dcterms:modified xsi:type="dcterms:W3CDTF">2013-06-11T02:57:00Z</dcterms:modified>
</cp:coreProperties>
</file>